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991" autoAdjust="0"/>
    <p:restoredTop sz="94660"/>
  </p:normalViewPr>
  <p:slideViewPr>
    <p:cSldViewPr snapToGrid="0">
      <p:cViewPr varScale="1">
        <p:scale>
          <a:sx n="132" d="100"/>
          <a:sy n="132" d="100"/>
        </p:scale>
        <p:origin x="156" y="8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gtvault-my.sharepoint.com/personal/schockalingam6_gatech_edu1/Documents/I3-Networks/All-Tabl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gtvault-my.sharepoint.com/personal/schockalingam6_gatech_edu1/Documents/I3-Networks/All-Tabl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127614481439154"/>
          <c:y val="7.4222613137212484E-2"/>
          <c:w val="0.71068176420614393"/>
          <c:h val="0.76999150004757633"/>
        </c:manualLayout>
      </c:layout>
      <c:scatterChart>
        <c:scatterStyle val="lineMarker"/>
        <c:varyColors val="0"/>
        <c:ser>
          <c:idx val="0"/>
          <c:order val="0"/>
          <c:tx>
            <c:strRef>
              <c:f>'Table S7'!$G$14</c:f>
              <c:strCache>
                <c:ptCount val="1"/>
                <c:pt idx="0">
                  <c:v>ComBat</c:v>
                </c:pt>
              </c:strCache>
            </c:strRef>
          </c:tx>
          <c:spPr>
            <a:ln w="19050" cap="rnd">
              <a:solidFill>
                <a:srgbClr val="92D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xVal>
            <c:numRef>
              <c:f>'Table S7'!$C$15:$C$22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G$15:$G$22</c:f>
              <c:numCache>
                <c:formatCode>0.00</c:formatCode>
                <c:ptCount val="8"/>
                <c:pt idx="0">
                  <c:v>8.0162887573242099</c:v>
                </c:pt>
                <c:pt idx="1">
                  <c:v>17.775211334228501</c:v>
                </c:pt>
                <c:pt idx="2">
                  <c:v>29.691070556640625</c:v>
                </c:pt>
                <c:pt idx="3">
                  <c:v>72.976078033447195</c:v>
                </c:pt>
                <c:pt idx="4">
                  <c:v>154.12825393676758</c:v>
                </c:pt>
                <c:pt idx="5">
                  <c:v>231.08670806884766</c:v>
                </c:pt>
                <c:pt idx="6">
                  <c:v>295.27630996704102</c:v>
                </c:pt>
                <c:pt idx="7">
                  <c:v>508.03868484497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E05-4FE6-9276-0543B5321E71}"/>
            </c:ext>
          </c:extLst>
        </c:ser>
        <c:ser>
          <c:idx val="1"/>
          <c:order val="1"/>
          <c:tx>
            <c:strRef>
              <c:f>'Table S7'!$H$14</c:f>
              <c:strCache>
                <c:ptCount val="1"/>
                <c:pt idx="0">
                  <c:v>PySCEMENT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S7'!$C$15:$C$22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H$15:$H$22</c:f>
              <c:numCache>
                <c:formatCode>0.00</c:formatCode>
                <c:ptCount val="8"/>
                <c:pt idx="0">
                  <c:v>2.3249130249023402</c:v>
                </c:pt>
                <c:pt idx="1">
                  <c:v>4.5769844055175701</c:v>
                </c:pt>
                <c:pt idx="2">
                  <c:v>10.167102813720703</c:v>
                </c:pt>
                <c:pt idx="3">
                  <c:v>21.0023803710937</c:v>
                </c:pt>
                <c:pt idx="4">
                  <c:v>53.484077453613281</c:v>
                </c:pt>
                <c:pt idx="5">
                  <c:v>80.083503723144531</c:v>
                </c:pt>
                <c:pt idx="6">
                  <c:v>101.71927642822266</c:v>
                </c:pt>
                <c:pt idx="7">
                  <c:v>175.451435089111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E05-4FE6-9276-0543B5321E71}"/>
            </c:ext>
          </c:extLst>
        </c:ser>
        <c:ser>
          <c:idx val="2"/>
          <c:order val="2"/>
          <c:tx>
            <c:strRef>
              <c:f>'Table S7'!$I$14</c:f>
              <c:strCache>
                <c:ptCount val="1"/>
                <c:pt idx="0">
                  <c:v>SCEMENT-CPP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able S7'!$C$15:$C$22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I$15:$I$22</c:f>
              <c:numCache>
                <c:formatCode>0.00</c:formatCode>
                <c:ptCount val="8"/>
                <c:pt idx="0">
                  <c:v>1.0506668090820299</c:v>
                </c:pt>
                <c:pt idx="1">
                  <c:v>2.21718978881835</c:v>
                </c:pt>
                <c:pt idx="2">
                  <c:v>4.23028564453125</c:v>
                </c:pt>
                <c:pt idx="3">
                  <c:v>11.009700775146401</c:v>
                </c:pt>
                <c:pt idx="4">
                  <c:v>24.531795501708899</c:v>
                </c:pt>
                <c:pt idx="5">
                  <c:v>35.757396697997997</c:v>
                </c:pt>
                <c:pt idx="6">
                  <c:v>46.754020690917898</c:v>
                </c:pt>
                <c:pt idx="7">
                  <c:v>82.536376953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E05-4FE6-9276-0543B5321E71}"/>
            </c:ext>
          </c:extLst>
        </c:ser>
        <c:ser>
          <c:idx val="3"/>
          <c:order val="3"/>
          <c:tx>
            <c:strRef>
              <c:f>'Table S7'!$J$14</c:f>
              <c:strCache>
                <c:ptCount val="1"/>
                <c:pt idx="0">
                  <c:v>Scanorama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Table S7'!$C$15:$C$22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J$15:$J$22</c:f>
              <c:numCache>
                <c:formatCode>0.00</c:formatCode>
                <c:ptCount val="8"/>
                <c:pt idx="0">
                  <c:v>15.568763732910156</c:v>
                </c:pt>
                <c:pt idx="1">
                  <c:v>19.390369415283203</c:v>
                </c:pt>
                <c:pt idx="2">
                  <c:v>39.188457489013672</c:v>
                </c:pt>
                <c:pt idx="3">
                  <c:v>138.85986328125</c:v>
                </c:pt>
                <c:pt idx="4">
                  <c:v>238.92608642578125</c:v>
                </c:pt>
                <c:pt idx="5">
                  <c:v>420.71256256103516</c:v>
                </c:pt>
                <c:pt idx="6">
                  <c:v>567.487400054931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E05-4FE6-9276-0543B5321E71}"/>
            </c:ext>
          </c:extLst>
        </c:ser>
        <c:ser>
          <c:idx val="4"/>
          <c:order val="4"/>
          <c:tx>
            <c:strRef>
              <c:f>'Table S7'!$K$14</c:f>
              <c:strCache>
                <c:ptCount val="1"/>
                <c:pt idx="0">
                  <c:v>FastIntegration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able S7'!$C$15:$C$22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K$15:$K$22</c:f>
              <c:numCache>
                <c:formatCode>0.00</c:formatCode>
                <c:ptCount val="8"/>
                <c:pt idx="0">
                  <c:v>4.0180816650390598</c:v>
                </c:pt>
                <c:pt idx="1">
                  <c:v>14.049602508544901</c:v>
                </c:pt>
                <c:pt idx="2">
                  <c:v>39.559108734130859</c:v>
                </c:pt>
                <c:pt idx="3">
                  <c:v>119.609279632568</c:v>
                </c:pt>
                <c:pt idx="4">
                  <c:v>163.68753814697266</c:v>
                </c:pt>
                <c:pt idx="5">
                  <c:v>212.58935165405273</c:v>
                </c:pt>
                <c:pt idx="6">
                  <c:v>263.10777282714844</c:v>
                </c:pt>
                <c:pt idx="7">
                  <c:v>323.666824340820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2E05-4FE6-9276-0543B5321E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8312032"/>
        <c:axId val="1528314112"/>
      </c:scatterChart>
      <c:valAx>
        <c:axId val="1528312032"/>
        <c:scaling>
          <c:orientation val="minMax"/>
          <c:max val="12500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Concourse T6" pitchFamily="2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No. of Cells</a:t>
                </a:r>
              </a:p>
            </c:rich>
          </c:tx>
          <c:layout>
            <c:manualLayout>
              <c:xMode val="edge"/>
              <c:yMode val="edge"/>
              <c:x val="0.42264583104208403"/>
              <c:y val="0.9292715184614821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Concourse T6" pitchFamily="2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#,##0\K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oncourse T6" pitchFamily="2" charset="0"/>
                <a:ea typeface="+mn-ea"/>
                <a:cs typeface="+mn-cs"/>
              </a:defRPr>
            </a:pPr>
            <a:endParaRPr lang="en-US"/>
          </a:p>
        </c:txPr>
        <c:crossAx val="1528314112"/>
        <c:crossesAt val="0"/>
        <c:crossBetween val="midCat"/>
        <c:majorUnit val="200000"/>
        <c:minorUnit val="50000"/>
        <c:dispUnits>
          <c:builtInUnit val="thousands"/>
        </c:dispUnits>
      </c:valAx>
      <c:valAx>
        <c:axId val="1528314112"/>
        <c:scaling>
          <c:orientation val="minMax"/>
          <c:max val="6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Concourse T6" pitchFamily="2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Memory (GB)</a:t>
                </a:r>
              </a:p>
            </c:rich>
          </c:tx>
          <c:layout>
            <c:manualLayout>
              <c:xMode val="edge"/>
              <c:yMode val="edge"/>
              <c:x val="2.3815709708149307E-2"/>
              <c:y val="0.345614763444569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Concourse T6" pitchFamily="2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oncourse T6" pitchFamily="2" charset="0"/>
                <a:ea typeface="+mn-ea"/>
                <a:cs typeface="+mn-cs"/>
              </a:defRPr>
            </a:pPr>
            <a:endParaRPr lang="en-US"/>
          </a:p>
        </c:txPr>
        <c:crossAx val="1528312032"/>
        <c:crossesAt val="0"/>
        <c:crossBetween val="midCat"/>
        <c:min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latin typeface="Concourse T6" pitchFamily="2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888060745490576"/>
          <c:y val="7.4772204996100863E-2"/>
          <c:w val="0.71337734100667094"/>
          <c:h val="0.76732270635508326"/>
        </c:manualLayout>
      </c:layout>
      <c:scatterChart>
        <c:scatterStyle val="lineMarker"/>
        <c:varyColors val="0"/>
        <c:ser>
          <c:idx val="0"/>
          <c:order val="0"/>
          <c:tx>
            <c:strRef>
              <c:f>'Table S7'!$G$2</c:f>
              <c:strCache>
                <c:ptCount val="1"/>
                <c:pt idx="0">
                  <c:v>ComBat </c:v>
                </c:pt>
              </c:strCache>
            </c:strRef>
          </c:tx>
          <c:spPr>
            <a:ln w="19050" cap="rnd">
              <a:solidFill>
                <a:srgbClr val="92D05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92D050"/>
              </a:solidFill>
              <a:ln w="9525">
                <a:solidFill>
                  <a:srgbClr val="92D050"/>
                </a:solidFill>
              </a:ln>
              <a:effectLst/>
            </c:spPr>
          </c:marker>
          <c:xVal>
            <c:numRef>
              <c:f>'Table S7'!$C$3:$C$10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G$3:$G$10</c:f>
              <c:numCache>
                <c:formatCode>0.000</c:formatCode>
                <c:ptCount val="8"/>
                <c:pt idx="0">
                  <c:v>0.56480333333333299</c:v>
                </c:pt>
                <c:pt idx="1">
                  <c:v>1.2333333333333301</c:v>
                </c:pt>
                <c:pt idx="2">
                  <c:v>2.41</c:v>
                </c:pt>
                <c:pt idx="3">
                  <c:v>6.3466983333333298</c:v>
                </c:pt>
                <c:pt idx="4">
                  <c:v>14.44</c:v>
                </c:pt>
                <c:pt idx="5">
                  <c:v>22.89</c:v>
                </c:pt>
                <c:pt idx="6">
                  <c:v>31.49</c:v>
                </c:pt>
                <c:pt idx="7">
                  <c:v>53.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DBC-405C-AEBA-7A8A418008D1}"/>
            </c:ext>
          </c:extLst>
        </c:ser>
        <c:ser>
          <c:idx val="1"/>
          <c:order val="1"/>
          <c:tx>
            <c:strRef>
              <c:f>'Table S7'!$H$2</c:f>
              <c:strCache>
                <c:ptCount val="1"/>
                <c:pt idx="0">
                  <c:v>PySCEMENT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able S7'!$C$3:$C$10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H$3:$H$10</c:f>
              <c:numCache>
                <c:formatCode>0.000</c:formatCode>
                <c:ptCount val="8"/>
                <c:pt idx="0">
                  <c:v>0.42392666666666601</c:v>
                </c:pt>
                <c:pt idx="1">
                  <c:v>1.1872366666666601</c:v>
                </c:pt>
                <c:pt idx="2">
                  <c:v>2.25</c:v>
                </c:pt>
                <c:pt idx="3">
                  <c:v>6.8639033333333304</c:v>
                </c:pt>
                <c:pt idx="4">
                  <c:v>18.010000000000002</c:v>
                </c:pt>
                <c:pt idx="5">
                  <c:v>28.57</c:v>
                </c:pt>
                <c:pt idx="6">
                  <c:v>40.89</c:v>
                </c:pt>
                <c:pt idx="7">
                  <c:v>89.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DBC-405C-AEBA-7A8A418008D1}"/>
            </c:ext>
          </c:extLst>
        </c:ser>
        <c:ser>
          <c:idx val="2"/>
          <c:order val="2"/>
          <c:tx>
            <c:strRef>
              <c:f>'Table S7'!$I$2</c:f>
              <c:strCache>
                <c:ptCount val="1"/>
                <c:pt idx="0">
                  <c:v>SCEMENT-CPP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able S7'!$C$3:$C$10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I$3:$I$10</c:f>
              <c:numCache>
                <c:formatCode>0.000</c:formatCode>
                <c:ptCount val="8"/>
                <c:pt idx="0">
                  <c:v>8.1916466666666604E-2</c:v>
                </c:pt>
                <c:pt idx="1">
                  <c:v>0.14214660000000001</c:v>
                </c:pt>
                <c:pt idx="2">
                  <c:v>0.266105066666666</c:v>
                </c:pt>
                <c:pt idx="3">
                  <c:v>0.94600566666666597</c:v>
                </c:pt>
                <c:pt idx="4">
                  <c:v>2.5925066666666599</c:v>
                </c:pt>
                <c:pt idx="5">
                  <c:v>4.2563883333333301</c:v>
                </c:pt>
                <c:pt idx="6">
                  <c:v>5.7132050000000003</c:v>
                </c:pt>
                <c:pt idx="7">
                  <c:v>13.8411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DBC-405C-AEBA-7A8A418008D1}"/>
            </c:ext>
          </c:extLst>
        </c:ser>
        <c:ser>
          <c:idx val="3"/>
          <c:order val="3"/>
          <c:tx>
            <c:strRef>
              <c:f>'Table S7'!$J$2</c:f>
              <c:strCache>
                <c:ptCount val="1"/>
                <c:pt idx="0">
                  <c:v>Scanorama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Table S7'!$C$3:$C$10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J$3:$J$10</c:f>
              <c:numCache>
                <c:formatCode>0.00</c:formatCode>
                <c:ptCount val="8"/>
                <c:pt idx="0">
                  <c:v>2.1337566666666663</c:v>
                </c:pt>
                <c:pt idx="1">
                  <c:v>3.607955</c:v>
                </c:pt>
                <c:pt idx="2">
                  <c:v>12.02</c:v>
                </c:pt>
                <c:pt idx="3">
                  <c:v>56.074451666666661</c:v>
                </c:pt>
                <c:pt idx="4">
                  <c:v>144.85</c:v>
                </c:pt>
                <c:pt idx="5">
                  <c:v>389.38</c:v>
                </c:pt>
                <c:pt idx="6">
                  <c:v>413.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DBC-405C-AEBA-7A8A418008D1}"/>
            </c:ext>
          </c:extLst>
        </c:ser>
        <c:ser>
          <c:idx val="4"/>
          <c:order val="4"/>
          <c:tx>
            <c:strRef>
              <c:f>'Table S7'!$K$2</c:f>
              <c:strCache>
                <c:ptCount val="1"/>
                <c:pt idx="0">
                  <c:v>FastIntegration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able S7'!$C$3:$C$10</c:f>
              <c:numCache>
                <c:formatCode>General</c:formatCode>
                <c:ptCount val="8"/>
                <c:pt idx="0">
                  <c:v>11540</c:v>
                </c:pt>
                <c:pt idx="1">
                  <c:v>25090</c:v>
                </c:pt>
                <c:pt idx="2">
                  <c:v>53276</c:v>
                </c:pt>
                <c:pt idx="3">
                  <c:v>150142</c:v>
                </c:pt>
                <c:pt idx="4">
                  <c:v>351954</c:v>
                </c:pt>
                <c:pt idx="5">
                  <c:v>502001</c:v>
                </c:pt>
                <c:pt idx="6">
                  <c:v>701072</c:v>
                </c:pt>
                <c:pt idx="7">
                  <c:v>1226553</c:v>
                </c:pt>
              </c:numCache>
            </c:numRef>
          </c:xVal>
          <c:yVal>
            <c:numRef>
              <c:f>'Table S7'!$K$3:$K$10</c:f>
              <c:numCache>
                <c:formatCode>0.00</c:formatCode>
                <c:ptCount val="8"/>
                <c:pt idx="0">
                  <c:v>1.6762220000000001</c:v>
                </c:pt>
                <c:pt idx="1">
                  <c:v>7.4704179999999996</c:v>
                </c:pt>
                <c:pt idx="2">
                  <c:v>32.11</c:v>
                </c:pt>
                <c:pt idx="3">
                  <c:v>172.84854000000001</c:v>
                </c:pt>
                <c:pt idx="4">
                  <c:v>346.79</c:v>
                </c:pt>
                <c:pt idx="5">
                  <c:v>503.94</c:v>
                </c:pt>
                <c:pt idx="6">
                  <c:v>793.21</c:v>
                </c:pt>
                <c:pt idx="7">
                  <c:v>1526.4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DBC-405C-AEBA-7A8A418008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28312032"/>
        <c:axId val="1528314112"/>
      </c:scatterChart>
      <c:valAx>
        <c:axId val="1528312032"/>
        <c:scaling>
          <c:orientation val="minMax"/>
          <c:max val="12500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Concourse T6" pitchFamily="2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No. of Cells</a:t>
                </a:r>
              </a:p>
            </c:rich>
          </c:tx>
          <c:layout>
            <c:manualLayout>
              <c:xMode val="edge"/>
              <c:yMode val="edge"/>
              <c:x val="0.42661973603211401"/>
              <c:y val="0.9305279060508071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Concourse T6" pitchFamily="2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#,##0\K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oncourse T6" pitchFamily="2" charset="0"/>
                <a:ea typeface="+mn-ea"/>
                <a:cs typeface="+mn-cs"/>
              </a:defRPr>
            </a:pPr>
            <a:endParaRPr lang="en-US"/>
          </a:p>
        </c:txPr>
        <c:crossAx val="1528314112"/>
        <c:crossesAt val="0"/>
        <c:crossBetween val="midCat"/>
        <c:majorUnit val="200000"/>
        <c:minorUnit val="50000"/>
        <c:dispUnits>
          <c:builtInUnit val="thousands"/>
        </c:dispUnits>
      </c:valAx>
      <c:valAx>
        <c:axId val="1528314112"/>
        <c:scaling>
          <c:orientation val="minMax"/>
          <c:max val="155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Concourse T6" pitchFamily="2" charset="0"/>
                    <a:ea typeface="+mn-ea"/>
                    <a:cs typeface="+mn-cs"/>
                  </a:defRPr>
                </a:pPr>
                <a:r>
                  <a:rPr lang="en-US" sz="1200" b="1">
                    <a:solidFill>
                      <a:schemeClr val="tx1"/>
                    </a:solidFill>
                  </a:rPr>
                  <a:t>Runtime (minutes)</a:t>
                </a:r>
              </a:p>
            </c:rich>
          </c:tx>
          <c:layout>
            <c:manualLayout>
              <c:xMode val="edge"/>
              <c:yMode val="edge"/>
              <c:x val="2.1119306575646736E-2"/>
              <c:y val="0.3013871029302243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Concourse T6" pitchFamily="2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Concourse T6" pitchFamily="2" charset="0"/>
                <a:ea typeface="+mn-ea"/>
                <a:cs typeface="+mn-cs"/>
              </a:defRPr>
            </a:pPr>
            <a:endParaRPr lang="en-US"/>
          </a:p>
        </c:txPr>
        <c:crossAx val="1528312032"/>
        <c:crossesAt val="0"/>
        <c:crossBetween val="midCat"/>
        <c:min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887241170091073"/>
          <c:y val="9.8920256199941867E-2"/>
          <c:w val="0.32452111761323804"/>
          <c:h val="0.25765115323463322"/>
        </c:manualLayout>
      </c:layout>
      <c:overlay val="0"/>
      <c:spPr>
        <a:solidFill>
          <a:sysClr val="window" lastClr="FFFFFF"/>
        </a:solidFill>
        <a:ln>
          <a:solidFill>
            <a:sysClr val="windowText" lastClr="000000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Concourse T6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latin typeface="Concourse T6" pitchFamily="2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A83B6-083E-065C-107A-B535518290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20DE35-91D6-B6F3-F644-C77AF95F6E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2F504-7B53-CEB0-CA0D-813C58CEA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4AD0F2-1CD1-25C5-C2D8-26ACD3D5E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A84C90-524D-EEAE-9745-E3FB95E60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4205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251C3-DDB1-C2EF-29FA-86F28C91FB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5D2973-F08F-6A4D-13DB-F383C6E54C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E3AE60-C4C3-22DF-CC42-0F574E813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5F72A5-D3E8-3C83-2B72-6EAA35839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70779-8E18-BE6E-78EA-4B8F29091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618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CB3F7D-4250-4A77-A804-107803721F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6B10A8-0FCF-11BB-0075-6F512CF865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AD3691-6025-1A7D-F90C-46FA86753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9FFD83-7CE9-467A-C909-5324F367F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732208-47FB-45B1-184C-3469F6CD8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451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8F054-09FF-FBD7-D889-E23A636829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226CBC-CABD-EB27-12C8-B8706FBDFF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A79279-1AE0-A894-F7ED-BEA88DC0F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A017E4-3D2C-F124-3635-AF65728EE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411494-7852-840A-D70B-42B6F5977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52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AD39F1-C6AA-BD71-EC8D-F5D31FB33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C8CA57-24BD-A497-CEC1-162CE96A94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887018-A383-C506-07E0-489F42BE0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520CB9-A8E6-8B60-E317-ACB679753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1C407-5C88-E070-9027-6D4D78573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649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1E2C0E-5BFE-B1A2-7A4D-7A074BAB22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888033-4C6C-F8BA-E36C-2C5E210CD3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CCD27B-F5DD-7732-FC88-57F11B3845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53EA29-1C67-85C0-66DA-2002A55AD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287CEB-2A65-DED6-3D19-8C0957573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FBE716-19C7-74BE-81F0-C9A61FEB1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1624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A71D7-ABEB-A545-A283-8DD8271D4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AA7FEB-B295-B313-B3C0-C34CE7A283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8BC3D5-6763-9851-F486-E96AD9B274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05A0BA-3990-BF92-B409-833A8D9EEA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0E68AE-C11A-47D1-541C-0E6A740690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E497DB-60F8-8536-E6BA-C1AF06C6A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24AAB7-835B-ADB2-1B04-28D0F55F0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CC5BA0-2EB8-00AB-1259-5A527C17F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745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A4B51-2AC0-A836-4470-937C595607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94C62F-FEFF-10E5-8045-335E40FA9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B320175-7F11-2FB7-A9AB-E0B49A64C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064D29-AAC2-4346-0AED-1338677B3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141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FFD398-62FB-EC93-A2A4-A849B7A67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F68241-E78B-2853-EBC3-05A0B59DC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58E42E-1D34-B086-5283-D716F3395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924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4E714-659D-628A-D264-7F2968F813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5477A6-9416-41FC-29AD-F26534E3FC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3C67BB-5CBA-D937-5C5C-B55BA868B6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DAD277-5926-1B90-7658-A6D2BF683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833919-30FF-55AC-0B49-DCC44FBFA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458F0E-E66A-D34B-245E-102272141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448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5C5018-5BB5-536E-B0C4-612E01897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186F04-7752-6760-3B39-C0D9B257EA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ADCDAB-1479-706C-8E9C-A784BC06EC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ACCFD1-D925-CC0D-14F7-D9CDF8513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A2BEE1-E4BF-9183-6FD0-295A321EB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04A72F-7474-CFB4-FF54-8DDD381C4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245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A9C3F6-E7EE-FC21-A66F-6605CD859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6AF019-3C79-C179-2D15-5DEEDD5772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826153-0B2E-7C87-2877-B2190CDE8F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5BA648-E0FB-4891-9FF5-F337F9E134A3}" type="datetimeFigureOut">
              <a:rPr lang="en-US" smtClean="0"/>
              <a:t>11/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EE42A9-2B1C-1ACB-9543-E1003E8FE1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2D0AA-8888-FEF1-2CB1-445AAB3A25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6C09306-A314-42FF-B5A9-04746415D0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713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A9FE9EC-0074-4251-8A2D-5C597FD898BB}"/>
              </a:ext>
            </a:extLst>
          </p:cNvPr>
          <p:cNvGraphicFramePr>
            <a:graphicFrameLocks/>
          </p:cNvGraphicFramePr>
          <p:nvPr/>
        </p:nvGraphicFramePr>
        <p:xfrm>
          <a:off x="6265502" y="1989655"/>
          <a:ext cx="3764322" cy="37623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E9F67EE1-C574-4872-9496-9F4105293B7B}"/>
              </a:ext>
            </a:extLst>
          </p:cNvPr>
          <p:cNvGraphicFramePr>
            <a:graphicFrameLocks/>
          </p:cNvGraphicFramePr>
          <p:nvPr/>
        </p:nvGraphicFramePr>
        <p:xfrm>
          <a:off x="2501180" y="1989655"/>
          <a:ext cx="3764322" cy="37623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590A4DD7-F085-DA51-0237-85255E1182ED}"/>
              </a:ext>
            </a:extLst>
          </p:cNvPr>
          <p:cNvSpPr txBox="1"/>
          <p:nvPr/>
        </p:nvSpPr>
        <p:spPr>
          <a:xfrm>
            <a:off x="723900" y="438150"/>
            <a:ext cx="10825399" cy="92333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Figure S3 -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ptos"/>
                <a:ea typeface="+mn-ea"/>
                <a:cs typeface="+mn-cs"/>
              </a:rPr>
              <a:t>Comparison of integration methods using matrices with intersection of genes for varying number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ptos"/>
                <a:ea typeface="+mn-ea"/>
                <a:cs typeface="+mn-cs"/>
              </a:rPr>
              <a:t>of COVID-19 datasets/cells/genes​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81594188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1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luru, Srinivas</dc:creator>
  <cp:lastModifiedBy>Aluru, Srinivas</cp:lastModifiedBy>
  <cp:revision>9</cp:revision>
  <dcterms:created xsi:type="dcterms:W3CDTF">2024-11-07T18:07:59Z</dcterms:created>
  <dcterms:modified xsi:type="dcterms:W3CDTF">2024-11-07T18:33:29Z</dcterms:modified>
</cp:coreProperties>
</file>